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46066-5FD4-4750-BCDC-D0CA65A17D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B0BEB-6C47-491D-909E-3CABABD371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240CD-A880-4254-AE45-23F8F45BE7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8DEF0-1411-4C17-9489-E4CC38DDB3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9304B-A1A8-45A5-9174-945030104C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1E478-AD31-4A23-87C1-9A667241F5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7EDB2-1557-4D62-8DEC-170089B6AE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A6077-C758-4280-8842-DCD5ABB558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09533-69A2-4CA1-9648-B5604C21F6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BFADD1-B5BE-4059-AC93-AD1C817F15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CDBF7-2331-49B0-9172-D9E0D03A17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4F19F-7409-4156-9887-4A7D8AD6D1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F874EC-FAB6-4330-8E06-F8EB842B4C78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8900000">
            <a:off x="2099880" y="5116320"/>
            <a:ext cx="144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rot="18900000">
            <a:off x="2519280" y="511128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8900000">
            <a:off x="2940120" y="511128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8900000">
            <a:off x="3350880" y="5116320"/>
            <a:ext cx="144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8900000">
            <a:off x="4165560" y="512100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8900000">
            <a:off x="4610160" y="510984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8900000">
            <a:off x="5440320" y="510984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6280" y="30240"/>
            <a:ext cx="162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Figure S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1127520" y="638280"/>
            <a:ext cx="4587480" cy="2131200"/>
            <a:chOff x="1127520" y="638280"/>
            <a:chExt cx="4587480" cy="2131200"/>
          </a:xfrm>
        </p:grpSpPr>
        <p:sp>
          <p:nvSpPr>
            <p:cNvPr id="50" name=""/>
            <p:cNvSpPr/>
            <p:nvPr/>
          </p:nvSpPr>
          <p:spPr>
            <a:xfrm>
              <a:off x="1871640" y="1271160"/>
              <a:ext cx="3726000" cy="123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957320" y="1946160"/>
              <a:ext cx="119160" cy="14868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373480" y="1968120"/>
              <a:ext cx="118800" cy="12672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787480" y="1449000"/>
              <a:ext cx="119160" cy="64584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197160" y="1917360"/>
              <a:ext cx="119160" cy="17748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613320" y="1925280"/>
              <a:ext cx="118800" cy="16956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027320" y="1676160"/>
              <a:ext cx="119160" cy="41868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443480" y="2060280"/>
              <a:ext cx="119160" cy="3456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853160" y="1974600"/>
              <a:ext cx="118800" cy="12024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267160" y="2068200"/>
              <a:ext cx="119160" cy="2664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076480" y="2031840"/>
              <a:ext cx="119160" cy="63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492280" y="2045880"/>
              <a:ext cx="117720" cy="489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906640" y="1954080"/>
              <a:ext cx="112680" cy="1407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316320" y="2080800"/>
              <a:ext cx="119160" cy="140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732120" y="2095200"/>
              <a:ext cx="117720" cy="219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146480" y="1982520"/>
              <a:ext cx="119160" cy="1123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562640" y="2088720"/>
              <a:ext cx="112680" cy="61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386320" y="2095200"/>
              <a:ext cx="119160" cy="932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2016000" y="1924920"/>
              <a:ext cx="1800" cy="20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996920" y="1925280"/>
              <a:ext cx="46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2432160" y="1946160"/>
              <a:ext cx="1440" cy="21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413080" y="194616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2847960" y="1428480"/>
              <a:ext cx="1440" cy="20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827440" y="142848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3255840" y="1904760"/>
              <a:ext cx="1800" cy="12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236760" y="190476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3672000" y="1917000"/>
              <a:ext cx="1440" cy="7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652920" y="1917360"/>
              <a:ext cx="46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4087800" y="1647720"/>
              <a:ext cx="1440" cy="28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067280" y="164772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4503600" y="2045520"/>
              <a:ext cx="1800" cy="14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483080" y="2045880"/>
              <a:ext cx="46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4911840" y="1939680"/>
              <a:ext cx="1440" cy="34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892760" y="193968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5327640" y="2031840"/>
              <a:ext cx="1440" cy="36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307120" y="203184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2135160" y="2002680"/>
              <a:ext cx="1440" cy="28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116080" y="2003040"/>
              <a:ext cx="46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2550960" y="1974240"/>
              <a:ext cx="1800" cy="70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530440" y="1974600"/>
              <a:ext cx="475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2959200" y="1796760"/>
              <a:ext cx="1440" cy="156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940120" y="1796760"/>
              <a:ext cx="46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3375000" y="2045880"/>
              <a:ext cx="1440" cy="34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355920" y="2045880"/>
              <a:ext cx="46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3790800" y="2074680"/>
              <a:ext cx="1800" cy="42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770280" y="2074680"/>
              <a:ext cx="475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4206960" y="1896480"/>
              <a:ext cx="1440" cy="85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186080" y="189684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4614840" y="2074680"/>
              <a:ext cx="1440" cy="13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595760" y="2074680"/>
              <a:ext cx="460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5030640" y="2080440"/>
              <a:ext cx="1800" cy="14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010120" y="208080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5446800" y="2094840"/>
              <a:ext cx="1440" cy="9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425920" y="2095200"/>
              <a:ext cx="46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871640" y="1271160"/>
              <a:ext cx="1440" cy="1236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832040" y="209520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832040" y="1684080"/>
              <a:ext cx="39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832040" y="127116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871640" y="2095200"/>
              <a:ext cx="37260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122800" y="666360"/>
              <a:ext cx="461880" cy="41256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168880" y="738000"/>
              <a:ext cx="79560" cy="85320"/>
            </a:xfrm>
            <a:prstGeom prst="rect">
              <a:avLst/>
            </a:prstGeom>
            <a:solidFill>
              <a:srgbClr val="96969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334120" y="709200"/>
              <a:ext cx="293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</a:rPr>
                <a:t>W.T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</a:rPr>
                <a:t>.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168880" y="944280"/>
              <a:ext cx="79560" cy="853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343120" y="915840"/>
              <a:ext cx="70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</a:rPr>
                <a:t>y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4" name="" descr=""/>
            <p:cNvPicPr/>
            <p:nvPr/>
          </p:nvPicPr>
          <p:blipFill>
            <a:blip r:embed="rId1"/>
            <a:stretch/>
          </p:blipFill>
          <p:spPr>
            <a:xfrm>
              <a:off x="3305160" y="1693440"/>
              <a:ext cx="123840" cy="123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" descr=""/>
            <p:cNvPicPr/>
            <p:nvPr/>
          </p:nvPicPr>
          <p:blipFill>
            <a:blip r:embed="rId2"/>
            <a:stretch/>
          </p:blipFill>
          <p:spPr>
            <a:xfrm>
              <a:off x="3728880" y="1699920"/>
              <a:ext cx="123840" cy="123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6" name=""/>
            <p:cNvSpPr/>
            <p:nvPr/>
          </p:nvSpPr>
          <p:spPr>
            <a:xfrm>
              <a:off x="1338120" y="928440"/>
              <a:ext cx="266760" cy="875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rot="16200000">
              <a:off x="442080" y="1776240"/>
              <a:ext cx="1739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trans. level  (Log1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490120" y="795240"/>
              <a:ext cx="223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ully expanded leav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rot="18757200">
              <a:off x="1709640" y="2195640"/>
              <a:ext cx="54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rot="18742200">
              <a:off x="2160360" y="2207160"/>
              <a:ext cx="50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P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rot="18757200">
              <a:off x="3415320" y="2212920"/>
              <a:ext cx="49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F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rot="18757200">
              <a:off x="2511000" y="2179800"/>
              <a:ext cx="58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CH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rot="18742200">
              <a:off x="2996280" y="221076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CH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rot="18757200">
              <a:off x="4435560" y="2229120"/>
              <a:ext cx="82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MYB4-lik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rot="18757200">
              <a:off x="4084560" y="2284560"/>
              <a:ext cx="67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THM2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rot="18757200">
              <a:off x="3866400" y="2236680"/>
              <a:ext cx="42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127520" y="7394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rot="18757200">
              <a:off x="4937400" y="2262960"/>
              <a:ext cx="66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MYB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105520" y="638280"/>
              <a:ext cx="609480" cy="456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0" name=""/>
            <p:cNvGrpSpPr/>
            <p:nvPr/>
          </p:nvGrpSpPr>
          <p:grpSpPr>
            <a:xfrm>
              <a:off x="5194440" y="833040"/>
              <a:ext cx="469800" cy="448560"/>
              <a:chOff x="5194440" y="833040"/>
              <a:chExt cx="469800" cy="448560"/>
            </a:xfrm>
          </p:grpSpPr>
          <p:sp>
            <p:nvSpPr>
              <p:cNvPr id="131" name=""/>
              <p:cNvSpPr/>
              <p:nvPr/>
            </p:nvSpPr>
            <p:spPr>
              <a:xfrm>
                <a:off x="5194440" y="833040"/>
                <a:ext cx="469800" cy="44856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5240160" y="902880"/>
                <a:ext cx="84240" cy="9180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5383800" y="87588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5240160" y="1113840"/>
                <a:ext cx="84240" cy="9000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5426280" y="1085040"/>
                <a:ext cx="67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"/>
            <p:cNvSpPr/>
            <p:nvPr/>
          </p:nvSpPr>
          <p:spPr>
            <a:xfrm>
              <a:off x="1448280" y="155232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448280" y="115560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435680" y="237456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0.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9" name=""/>
          <p:cNvGrpSpPr/>
          <p:nvPr/>
        </p:nvGrpSpPr>
        <p:grpSpPr>
          <a:xfrm>
            <a:off x="1140120" y="2797200"/>
            <a:ext cx="4524120" cy="2356200"/>
            <a:chOff x="1140120" y="2797200"/>
            <a:chExt cx="4524120" cy="2356200"/>
          </a:xfrm>
        </p:grpSpPr>
        <p:sp>
          <p:nvSpPr>
            <p:cNvPr id="140" name=""/>
            <p:cNvSpPr/>
            <p:nvPr/>
          </p:nvSpPr>
          <p:spPr>
            <a:xfrm>
              <a:off x="1241280" y="3370320"/>
              <a:ext cx="266760" cy="87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6200000">
              <a:off x="445320" y="3844080"/>
              <a:ext cx="1739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trans. level  (Log1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898000" y="2843280"/>
              <a:ext cx="143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Young leav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140120" y="279720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4" name=""/>
            <p:cNvGrpSpPr/>
            <p:nvPr/>
          </p:nvGrpSpPr>
          <p:grpSpPr>
            <a:xfrm>
              <a:off x="1529640" y="3316320"/>
              <a:ext cx="4067640" cy="1431360"/>
              <a:chOff x="1529640" y="3316320"/>
              <a:chExt cx="4067640" cy="1431360"/>
            </a:xfrm>
          </p:grpSpPr>
          <p:sp>
            <p:nvSpPr>
              <p:cNvPr id="145" name=""/>
              <p:cNvSpPr/>
              <p:nvPr/>
            </p:nvSpPr>
            <p:spPr>
              <a:xfrm>
                <a:off x="1854000" y="3379680"/>
                <a:ext cx="3743280" cy="12938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1939680" y="4086000"/>
                <a:ext cx="123840" cy="37008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357280" y="4141800"/>
                <a:ext cx="123840" cy="31428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773080" y="3525840"/>
                <a:ext cx="117360" cy="93024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184200" y="3911400"/>
                <a:ext cx="123840" cy="54468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601800" y="3911400"/>
                <a:ext cx="123840" cy="54468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4019400" y="3632040"/>
                <a:ext cx="123840" cy="82404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4436640" y="4268520"/>
                <a:ext cx="117720" cy="18756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847760" y="4030560"/>
                <a:ext cx="123840" cy="42552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5265360" y="3722400"/>
                <a:ext cx="123840" cy="73368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2063520" y="4135320"/>
                <a:ext cx="117360" cy="3207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481120" y="4184640"/>
                <a:ext cx="117360" cy="27144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2890440" y="3484440"/>
                <a:ext cx="117720" cy="97164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308040" y="3911400"/>
                <a:ext cx="117360" cy="54468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725640" y="3911400"/>
                <a:ext cx="117360" cy="54468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4143240" y="3597120"/>
                <a:ext cx="117360" cy="8589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554360" y="4281480"/>
                <a:ext cx="117360" cy="17460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4971600" y="4010040"/>
                <a:ext cx="117720" cy="44604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5389200" y="3771720"/>
                <a:ext cx="117360" cy="6843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 flipV="1">
                <a:off x="1998360" y="4057200"/>
                <a:ext cx="0" cy="28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977840" y="4057560"/>
                <a:ext cx="460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 flipV="1">
                <a:off x="2415960" y="41274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395080" y="4127400"/>
                <a:ext cx="460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V="1">
                <a:off x="2831760" y="3490560"/>
                <a:ext cx="1440" cy="349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2812680" y="3490920"/>
                <a:ext cx="460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V="1">
                <a:off x="3242880" y="3903480"/>
                <a:ext cx="1800" cy="79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3223800" y="3903480"/>
                <a:ext cx="460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 flipV="1">
                <a:off x="3660480" y="389700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3641400" y="3897360"/>
                <a:ext cx="460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V="1">
                <a:off x="4078080" y="3609720"/>
                <a:ext cx="1440" cy="223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4059000" y="3609720"/>
                <a:ext cx="460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V="1">
                <a:off x="4495320" y="4246200"/>
                <a:ext cx="1800" cy="219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4476600" y="4246560"/>
                <a:ext cx="457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V="1">
                <a:off x="4906800" y="3980880"/>
                <a:ext cx="1440" cy="493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4887720" y="3981240"/>
                <a:ext cx="442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V="1">
                <a:off x="5324040" y="3652560"/>
                <a:ext cx="1800" cy="69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5304960" y="3652560"/>
                <a:ext cx="4464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V="1">
                <a:off x="2122200" y="4114440"/>
                <a:ext cx="1440" cy="205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2101680" y="4114800"/>
                <a:ext cx="457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 flipV="1">
                <a:off x="2539800" y="4155840"/>
                <a:ext cx="1440" cy="28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2518920" y="4155840"/>
                <a:ext cx="460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 flipV="1">
                <a:off x="2949120" y="3455640"/>
                <a:ext cx="1800" cy="28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2930040" y="3456000"/>
                <a:ext cx="460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 flipV="1">
                <a:off x="3366720" y="3890520"/>
                <a:ext cx="1800" cy="205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3347640" y="3890880"/>
                <a:ext cx="460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 flipV="1">
                <a:off x="3784320" y="3876120"/>
                <a:ext cx="1440" cy="349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3765240" y="3876480"/>
                <a:ext cx="460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V="1">
                <a:off x="4201920" y="35827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4182840" y="3582720"/>
                <a:ext cx="460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V="1">
                <a:off x="4613040" y="4246200"/>
                <a:ext cx="1440" cy="349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4593960" y="4246560"/>
                <a:ext cx="460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flipV="1">
                <a:off x="5030640" y="3938040"/>
                <a:ext cx="1440" cy="71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5011560" y="3938400"/>
                <a:ext cx="442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V="1">
                <a:off x="5447880" y="3714120"/>
                <a:ext cx="1800" cy="572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5428800" y="3714480"/>
                <a:ext cx="4464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1854000" y="3379680"/>
                <a:ext cx="1440" cy="129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1821960" y="4673520"/>
                <a:ext cx="32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1821960" y="4240080"/>
                <a:ext cx="32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1821960" y="3813120"/>
                <a:ext cx="32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1821960" y="3379680"/>
                <a:ext cx="32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1854000" y="4456080"/>
                <a:ext cx="37432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1529640" y="4610160"/>
                <a:ext cx="2995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1562760" y="4176720"/>
                <a:ext cx="2613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1562760" y="3749400"/>
                <a:ext cx="2613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5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1562760" y="3316320"/>
                <a:ext cx="2613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.5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0" name=""/>
            <p:cNvGrpSpPr/>
            <p:nvPr/>
          </p:nvGrpSpPr>
          <p:grpSpPr>
            <a:xfrm>
              <a:off x="5194440" y="2860560"/>
              <a:ext cx="469800" cy="449280"/>
              <a:chOff x="5194440" y="2860560"/>
              <a:chExt cx="469800" cy="449280"/>
            </a:xfrm>
          </p:grpSpPr>
          <p:sp>
            <p:nvSpPr>
              <p:cNvPr id="211" name=""/>
              <p:cNvSpPr/>
              <p:nvPr/>
            </p:nvSpPr>
            <p:spPr>
              <a:xfrm>
                <a:off x="5194440" y="2860560"/>
                <a:ext cx="469800" cy="44928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240160" y="2930400"/>
                <a:ext cx="84240" cy="92160"/>
              </a:xfrm>
              <a:prstGeom prst="rect">
                <a:avLst/>
              </a:prstGeom>
              <a:solidFill>
                <a:srgbClr val="969696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383800" y="290340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240160" y="3141720"/>
                <a:ext cx="84240" cy="903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5426280" y="3112920"/>
                <a:ext cx="67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6" name=""/>
            <p:cNvSpPr/>
            <p:nvPr/>
          </p:nvSpPr>
          <p:spPr>
            <a:xfrm rot="18757200">
              <a:off x="1701720" y="4530600"/>
              <a:ext cx="54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rot="18742200">
              <a:off x="2149200" y="4541040"/>
              <a:ext cx="50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P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rot="18757200">
              <a:off x="3409200" y="4547520"/>
              <a:ext cx="49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F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rot="18757200">
              <a:off x="2482200" y="4537440"/>
              <a:ext cx="58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CH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rot="18742200">
              <a:off x="2986920" y="4543920"/>
              <a:ext cx="49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CH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rot="18757200">
              <a:off x="4419720" y="4644360"/>
              <a:ext cx="82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MYB4-lik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rot="18757200">
              <a:off x="4079520" y="4594680"/>
              <a:ext cx="67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THM2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rot="18757200">
              <a:off x="3877200" y="4564440"/>
              <a:ext cx="42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rot="18757200">
              <a:off x="4927680" y="4600080"/>
              <a:ext cx="66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MYB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5" name=""/>
          <p:cNvGrpSpPr/>
          <p:nvPr/>
        </p:nvGrpSpPr>
        <p:grpSpPr>
          <a:xfrm>
            <a:off x="1133640" y="5033880"/>
            <a:ext cx="3692520" cy="2509560"/>
            <a:chOff x="1133640" y="5033880"/>
            <a:chExt cx="3692520" cy="2509560"/>
          </a:xfrm>
        </p:grpSpPr>
        <p:sp>
          <p:nvSpPr>
            <p:cNvPr id="226" name=""/>
            <p:cNvSpPr/>
            <p:nvPr/>
          </p:nvSpPr>
          <p:spPr>
            <a:xfrm>
              <a:off x="1133640" y="50338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1916280" y="5033880"/>
              <a:ext cx="2294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oots (LC-QTOF-MS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8" name="" descr=""/>
            <p:cNvPicPr/>
            <p:nvPr/>
          </p:nvPicPr>
          <p:blipFill>
            <a:blip r:embed="rId3"/>
            <a:srcRect l="17185" t="4326" r="18960" b="0"/>
            <a:stretch/>
          </p:blipFill>
          <p:spPr>
            <a:xfrm>
              <a:off x="1816200" y="5398920"/>
              <a:ext cx="2332080" cy="214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9" name=""/>
            <p:cNvSpPr/>
            <p:nvPr/>
          </p:nvSpPr>
          <p:spPr>
            <a:xfrm>
              <a:off x="2705040" y="7142040"/>
              <a:ext cx="63720" cy="63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560" bIns="1656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2336760" y="6214680"/>
              <a:ext cx="73080" cy="73080"/>
            </a:xfrm>
            <a:prstGeom prst="ellips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2817720" y="6835680"/>
              <a:ext cx="63720" cy="63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560" bIns="1656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165480" y="6554520"/>
              <a:ext cx="63360" cy="63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560" bIns="1656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510000" y="6590880"/>
              <a:ext cx="63360" cy="63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920" bIns="1692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957480" y="6335640"/>
              <a:ext cx="63720" cy="63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560" bIns="1656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874960" y="5876640"/>
              <a:ext cx="73080" cy="73080"/>
            </a:xfrm>
            <a:prstGeom prst="ellips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292560" y="5741640"/>
              <a:ext cx="73080" cy="73080"/>
            </a:xfrm>
            <a:prstGeom prst="ellips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2922480" y="5695560"/>
              <a:ext cx="73080" cy="73080"/>
            </a:xfrm>
            <a:prstGeom prst="ellips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2870280" y="5465520"/>
              <a:ext cx="73080" cy="73080"/>
            </a:xfrm>
            <a:prstGeom prst="ellips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9" name=""/>
            <p:cNvGrpSpPr/>
            <p:nvPr/>
          </p:nvGrpSpPr>
          <p:grpSpPr>
            <a:xfrm>
              <a:off x="4216320" y="5465520"/>
              <a:ext cx="609840" cy="482400"/>
              <a:chOff x="4216320" y="5465520"/>
              <a:chExt cx="609840" cy="482400"/>
            </a:xfrm>
          </p:grpSpPr>
          <p:sp>
            <p:nvSpPr>
              <p:cNvPr id="240" name=""/>
              <p:cNvSpPr/>
              <p:nvPr/>
            </p:nvSpPr>
            <p:spPr>
              <a:xfrm>
                <a:off x="4387320" y="5489280"/>
                <a:ext cx="41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4477320" y="5641560"/>
                <a:ext cx="247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4216320" y="5465520"/>
                <a:ext cx="609840" cy="4824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4351320" y="5600520"/>
                <a:ext cx="73080" cy="727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5040" bIns="504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4351320" y="5762160"/>
                <a:ext cx="63360" cy="637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6920" bIns="1692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45" name=""/>
          <p:cNvGrpSpPr/>
          <p:nvPr/>
        </p:nvGrpSpPr>
        <p:grpSpPr>
          <a:xfrm>
            <a:off x="1730520" y="5640480"/>
            <a:ext cx="2077200" cy="1981440"/>
            <a:chOff x="1730520" y="5640480"/>
            <a:chExt cx="2077200" cy="1981440"/>
          </a:xfrm>
        </p:grpSpPr>
        <p:sp>
          <p:nvSpPr>
            <p:cNvPr id="246" name=""/>
            <p:cNvSpPr/>
            <p:nvPr/>
          </p:nvSpPr>
          <p:spPr>
            <a:xfrm rot="16200000">
              <a:off x="1148400" y="6222600"/>
              <a:ext cx="14104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A2 – 21.4% varian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2397240" y="7375680"/>
              <a:ext cx="14104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A2 – 60.6% varian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8" name=""/>
          <p:cNvSpPr/>
          <p:nvPr/>
        </p:nvSpPr>
        <p:spPr>
          <a:xfrm>
            <a:off x="1077840" y="690480"/>
            <a:ext cx="4710240" cy="69296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3:47:16Z</dcterms:modified>
  <cp:revision>8</cp:revision>
  <dc:subject/>
  <dc:title>Slide 1</dc:title>
</cp:coreProperties>
</file>